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emf" ContentType="image/x-e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openxmlformats.org/officeDocument/2006/relationships/customXml" Target="../customXml/item2.xml"/><Relationship Id="rId5" Type="http://schemas.openxmlformats.org/officeDocument/2006/relationships/slide" Target="slides/slide4.xml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41FD-50FF-42F4-8497-20D450B5A55E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DA762-126B-4C29-B35D-FE5655A1D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427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41FD-50FF-42F4-8497-20D450B5A55E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DA762-126B-4C29-B35D-FE5655A1D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590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41FD-50FF-42F4-8497-20D450B5A55E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DA762-126B-4C29-B35D-FE5655A1D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386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41FD-50FF-42F4-8497-20D450B5A55E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DA762-126B-4C29-B35D-FE5655A1D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948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41FD-50FF-42F4-8497-20D450B5A55E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DA762-126B-4C29-B35D-FE5655A1D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8146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41FD-50FF-42F4-8497-20D450B5A55E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DA762-126B-4C29-B35D-FE5655A1D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8158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41FD-50FF-42F4-8497-20D450B5A55E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DA762-126B-4C29-B35D-FE5655A1D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639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41FD-50FF-42F4-8497-20D450B5A55E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DA762-126B-4C29-B35D-FE5655A1D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786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41FD-50FF-42F4-8497-20D450B5A55E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DA762-126B-4C29-B35D-FE5655A1D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5028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41FD-50FF-42F4-8497-20D450B5A55E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DA762-126B-4C29-B35D-FE5655A1D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255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D41FD-50FF-42F4-8497-20D450B5A55E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DA762-126B-4C29-B35D-FE5655A1D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178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3D41FD-50FF-42F4-8497-20D450B5A55E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CDA762-126B-4C29-B35D-FE5655A1D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339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0" y="533400"/>
            <a:ext cx="5943600" cy="3975100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Rectangle 6"/>
          <p:cNvSpPr/>
          <p:nvPr/>
        </p:nvSpPr>
        <p:spPr>
          <a:xfrm>
            <a:off x="533400" y="4876800"/>
            <a:ext cx="70104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Supplementary Figure 1: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IR spectrum of compound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SH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28340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1306" y="609600"/>
            <a:ext cx="6219825" cy="4400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2321825" y="5007780"/>
            <a:ext cx="415318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Supplementary Figure 2: </a:t>
            </a:r>
            <a:r>
              <a:rPr lang="en-US" sz="1600" baseline="30000" dirty="0">
                <a:latin typeface="Times New Roman" pitchFamily="18" charset="0"/>
                <a:cs typeface="Times New Roman" pitchFamily="18" charset="0"/>
              </a:rPr>
              <a:t>13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C spectrum of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SH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35317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7800" y="304800"/>
            <a:ext cx="6836260" cy="47307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2371109" y="5410200"/>
            <a:ext cx="387317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Supplementary Figure 3: 1H spectrum of SH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91666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685800"/>
            <a:ext cx="7315200" cy="4257993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/>
          <p:nvPr/>
        </p:nvSpPr>
        <p:spPr>
          <a:xfrm>
            <a:off x="1143000" y="5257800"/>
            <a:ext cx="54102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Supplementary Figure 4: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Mass spectrum of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SH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8860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1.PPTX</DocumentId>
    <TitleName xmlns="fa52ae8b-2b36-4137-9bde-d98e18ca3240">Presentation 1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219A6699-A038-4B94-ABE0-6833011194FE}"/>
</file>

<file path=customXml/itemProps2.xml><?xml version="1.0" encoding="utf-8"?>
<ds:datastoreItem xmlns:ds="http://schemas.openxmlformats.org/officeDocument/2006/customXml" ds:itemID="{B5E28216-FA16-44FE-92CB-E7DA08BEFDCC}"/>
</file>

<file path=customXml/itemProps3.xml><?xml version="1.0" encoding="utf-8"?>
<ds:datastoreItem xmlns:ds="http://schemas.openxmlformats.org/officeDocument/2006/customXml" ds:itemID="{9B597516-B37A-456A-A097-636908BBAED8}"/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3</Words>
  <Application>Microsoft Office PowerPoint</Application>
  <PresentationFormat>On-screen Show (4:3)</PresentationFormat>
  <Paragraphs>4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SHIBA</dc:creator>
  <cp:lastModifiedBy>TOSHIBA</cp:lastModifiedBy>
  <cp:revision>1</cp:revision>
  <dcterms:created xsi:type="dcterms:W3CDTF">2016-04-22T11:45:41Z</dcterms:created>
  <dcterms:modified xsi:type="dcterms:W3CDTF">2016-04-22T11:51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83BA409FEA174BB6E12A838B618002</vt:lpwstr>
  </property>
</Properties>
</file>